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89"/>
  </p:normalViewPr>
  <p:slideViewPr>
    <p:cSldViewPr snapToGrid="0" snapToObjects="1">
      <p:cViewPr varScale="1">
        <p:scale>
          <a:sx n="108" d="100"/>
          <a:sy n="108" d="100"/>
        </p:scale>
        <p:origin x="73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BB1507F-A08F-4049-8BF3-4FD5DB142F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9FB7404A-4643-ED4B-B597-475796C27A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6E05080-BD51-2D42-B4A0-AF94A6F883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0E1B7-0E31-7C4F-B2A8-2E56FD613E64}" type="datetimeFigureOut">
              <a:rPr kumimoji="1" lang="zh-CN" altLang="en-US" smtClean="0"/>
              <a:t>2020/2/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28683E7-63D4-0E44-8684-54D731E1AC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B362301-0E7D-A04E-9937-0BF0875CF3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83289-98D9-E746-AF86-F2688863457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338348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30BBDAC-FBA1-0640-A7BF-23070FE984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70E7739-BB18-BF4C-92B7-4A9D998CBF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1C56CD9-C3A0-A042-9AB6-9E656099EC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0E1B7-0E31-7C4F-B2A8-2E56FD613E64}" type="datetimeFigureOut">
              <a:rPr kumimoji="1" lang="zh-CN" altLang="en-US" smtClean="0"/>
              <a:t>2020/2/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41AD3D6-639B-874A-8521-3E908CF011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EF2A0F5-4575-1E49-B3F7-F0A090C298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83289-98D9-E746-AF86-F2688863457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4881226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3131501-B63D-854E-BB68-D2FAF09A4B9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11B16C0-4CBC-644A-B333-8963D9B500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48D3C3A-D555-8749-B035-61747C1150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0E1B7-0E31-7C4F-B2A8-2E56FD613E64}" type="datetimeFigureOut">
              <a:rPr kumimoji="1" lang="zh-CN" altLang="en-US" smtClean="0"/>
              <a:t>2020/2/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D427F3B-AB51-9B4A-88F9-9449A0250D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9AC5370-4669-1345-82E0-972B6A37E9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83289-98D9-E746-AF86-F2688863457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2579713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5E4811A-4696-B841-BEC7-0DB818A111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90DB69F-C819-7548-83AD-34A3E92E450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C46FF11-AB3A-C247-9CAB-3F66BA193B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0E1B7-0E31-7C4F-B2A8-2E56FD613E64}" type="datetimeFigureOut">
              <a:rPr kumimoji="1" lang="zh-CN" altLang="en-US" smtClean="0"/>
              <a:t>2020/2/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3099FF6-3AD6-EC43-8098-47C3855C0C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9663ADA-9285-B347-B4C7-8AA02DDA94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83289-98D9-E746-AF86-F2688863457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704018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CA2AA35-60B1-5A44-86DB-4AAC7F0334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E747FD8-6CB8-5D45-9C00-3DF8309C53D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7392908-3918-4E43-8EC8-DBE4EC3BD3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0E1B7-0E31-7C4F-B2A8-2E56FD613E64}" type="datetimeFigureOut">
              <a:rPr kumimoji="1" lang="zh-CN" altLang="en-US" smtClean="0"/>
              <a:t>2020/2/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E2B9AC8-BAD1-FF4D-AC04-391C1E26BA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5F3F0CA-4D5A-7C49-BE34-203BCCD9D0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83289-98D9-E746-AF86-F2688863457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29991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A54DA12-431A-AF42-B58B-7EC0503528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0131317-672B-F345-98DD-7B7ADFB60BC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CBC86C4-7D57-6340-9DAF-99F50261379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65889DA-DE97-8A40-99E3-6BAFCFEF3D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0E1B7-0E31-7C4F-B2A8-2E56FD613E64}" type="datetimeFigureOut">
              <a:rPr kumimoji="1" lang="zh-CN" altLang="en-US" smtClean="0"/>
              <a:t>2020/2/6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14FC598-719F-1544-9C5B-4A5F5BCE32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C8B3381-EDD8-DB42-9578-A7C57A9A96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83289-98D9-E746-AF86-F2688863457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1147200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CEAFA4E-8789-8B43-94F3-C91423F930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EA19DC9-8662-3E4B-AD21-C17D08F309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DF25811-F768-6B4E-B3DE-A4879CFFEB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31EA411B-B1DB-0B4C-96BF-608F91B54EE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741486AF-88E9-3A44-B823-61C00235F0D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2B33496-242C-9140-9BEB-EE5FED4E2E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0E1B7-0E31-7C4F-B2A8-2E56FD613E64}" type="datetimeFigureOut">
              <a:rPr kumimoji="1" lang="zh-CN" altLang="en-US" smtClean="0"/>
              <a:t>2020/2/6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17A549F-6DF6-5B44-BF1D-BEC733939F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2B44EFF9-0528-5E4B-95B9-90453A8421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83289-98D9-E746-AF86-F2688863457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522380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D80EBEA-D8B7-5748-B6A1-8891DFDD5F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574F682-D9F5-2245-8535-59109A8384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0E1B7-0E31-7C4F-B2A8-2E56FD613E64}" type="datetimeFigureOut">
              <a:rPr kumimoji="1" lang="zh-CN" altLang="en-US" smtClean="0"/>
              <a:t>2020/2/6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D24BCA5-096A-7443-BA93-EAB27DB171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B13A252-CA6B-CC46-88C5-4B60C318B2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83289-98D9-E746-AF86-F2688863457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225087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E6655A9-2A33-9A40-8B21-030F9044D4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0E1B7-0E31-7C4F-B2A8-2E56FD613E64}" type="datetimeFigureOut">
              <a:rPr kumimoji="1" lang="zh-CN" altLang="en-US" smtClean="0"/>
              <a:t>2020/2/6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2F38AB8-3314-074F-B41E-2BD93DDC14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DD82CC4-3A65-A240-9F89-D5DFA9C5E8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83289-98D9-E746-AF86-F2688863457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065953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0FB08A5-4FBD-814D-907E-ED7122E6A7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6C3BBCD-3E9B-7C4A-B636-245131499A8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69D5985-4B41-2445-880E-98DB650F6D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B52C294-C236-0344-A099-E42AE4A960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0E1B7-0E31-7C4F-B2A8-2E56FD613E64}" type="datetimeFigureOut">
              <a:rPr kumimoji="1" lang="zh-CN" altLang="en-US" smtClean="0"/>
              <a:t>2020/2/6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5BA5E62-0D4D-5243-A4AB-E27A71734A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68C897D-62BD-1E4B-8C15-54482AAC37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83289-98D9-E746-AF86-F2688863457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313100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7E60DAD-470E-2D49-A3A3-1077687FD7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C4E8D7C4-1E59-E64D-BA66-5B00BBF668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9ED3ED2-A60F-9146-A818-3E11120ACC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63B3102-6420-904E-BB10-09D04115E0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D0E1B7-0E31-7C4F-B2A8-2E56FD613E64}" type="datetimeFigureOut">
              <a:rPr kumimoji="1" lang="zh-CN" altLang="en-US" smtClean="0"/>
              <a:t>2020/2/6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FDFF831-B5B6-B44A-85B8-07254C5DF6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2BD97C8-7D98-C743-B10D-B68F39CE51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D83289-98D9-E746-AF86-F2688863457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440401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F867570-E67C-3941-A968-B352D671F9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B9098FE-2BA2-7C40-B495-A0EAC101D4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75D5A09-DD24-1542-BF50-692F8247592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D0E1B7-0E31-7C4F-B2A8-2E56FD613E64}" type="datetimeFigureOut">
              <a:rPr kumimoji="1" lang="zh-CN" altLang="en-US" smtClean="0"/>
              <a:t>2020/2/6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2DFC855-120E-2A47-90DC-B76D6CAEBCA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5490F94-443B-7940-B24A-B7DC91FB352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D83289-98D9-E746-AF86-F26888634578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03794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>
            <a:extLst>
              <a:ext uri="{FF2B5EF4-FFF2-40B4-BE49-F238E27FC236}">
                <a16:creationId xmlns:a16="http://schemas.microsoft.com/office/drawing/2014/main" id="{51F12136-4331-EF4F-A9A5-8D0C5C21701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70377678"/>
              </p:ext>
            </p:extLst>
          </p:nvPr>
        </p:nvGraphicFramePr>
        <p:xfrm>
          <a:off x="249381" y="280279"/>
          <a:ext cx="11693238" cy="5676197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493819">
                  <a:extLst>
                    <a:ext uri="{9D8B030D-6E8A-4147-A177-3AD203B41FA5}">
                      <a16:colId xmlns:a16="http://schemas.microsoft.com/office/drawing/2014/main" val="1527584287"/>
                    </a:ext>
                  </a:extLst>
                </a:gridCol>
                <a:gridCol w="1593931">
                  <a:extLst>
                    <a:ext uri="{9D8B030D-6E8A-4147-A177-3AD203B41FA5}">
                      <a16:colId xmlns:a16="http://schemas.microsoft.com/office/drawing/2014/main" val="2686358402"/>
                    </a:ext>
                  </a:extLst>
                </a:gridCol>
                <a:gridCol w="1901372">
                  <a:extLst>
                    <a:ext uri="{9D8B030D-6E8A-4147-A177-3AD203B41FA5}">
                      <a16:colId xmlns:a16="http://schemas.microsoft.com/office/drawing/2014/main" val="3934996839"/>
                    </a:ext>
                  </a:extLst>
                </a:gridCol>
                <a:gridCol w="1901372">
                  <a:extLst>
                    <a:ext uri="{9D8B030D-6E8A-4147-A177-3AD203B41FA5}">
                      <a16:colId xmlns:a16="http://schemas.microsoft.com/office/drawing/2014/main" val="1829561844"/>
                    </a:ext>
                  </a:extLst>
                </a:gridCol>
                <a:gridCol w="1901372">
                  <a:extLst>
                    <a:ext uri="{9D8B030D-6E8A-4147-A177-3AD203B41FA5}">
                      <a16:colId xmlns:a16="http://schemas.microsoft.com/office/drawing/2014/main" val="1912082662"/>
                    </a:ext>
                  </a:extLst>
                </a:gridCol>
                <a:gridCol w="1901372">
                  <a:extLst>
                    <a:ext uri="{9D8B030D-6E8A-4147-A177-3AD203B41FA5}">
                      <a16:colId xmlns:a16="http://schemas.microsoft.com/office/drawing/2014/main" val="2495453748"/>
                    </a:ext>
                  </a:extLst>
                </a:gridCol>
              </a:tblGrid>
              <a:tr h="440771">
                <a:tc>
                  <a:txBody>
                    <a:bodyPr/>
                    <a:lstStyle/>
                    <a:p>
                      <a:pPr algn="ctr"/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UC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%</a:t>
                      </a:r>
                      <a:r>
                        <a:rPr lang="zh-CN" altLang="en-US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I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zh-CN" altLang="en-US" sz="14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zh-CN" sz="14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lue</a:t>
                      </a:r>
                      <a:endParaRPr lang="zh-CN" altLang="en-US" sz="1400" i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nsitivity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ecificity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2347517"/>
                  </a:ext>
                </a:extLst>
              </a:tr>
              <a:tr h="440771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R-574-5p+miR-3679-5p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03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6-0.964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2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.25%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.75%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9255620"/>
                  </a:ext>
                </a:extLst>
              </a:tr>
              <a:tr h="440771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R-574-5p+miR-6165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789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6-1.002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3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.25%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.75%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7279767"/>
                  </a:ext>
                </a:extLst>
              </a:tr>
              <a:tr h="440771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R-574-5p+miR-6760-5p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297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41-1.018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.75%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.75%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3056533"/>
                  </a:ext>
                </a:extLst>
              </a:tr>
              <a:tr h="440771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R-3679-5p+miR-6165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93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33-0.953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7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.75%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.75%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9759910"/>
                  </a:ext>
                </a:extLst>
              </a:tr>
              <a:tr h="440771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R-3679-5p+miR-6760-5p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258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40-1.011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.00%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.50%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8458424"/>
                  </a:ext>
                </a:extLst>
              </a:tr>
              <a:tr h="440771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R-6165+miR-6760-5p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258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40-1.011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8.75%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.75%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7803536"/>
                  </a:ext>
                </a:extLst>
              </a:tr>
              <a:tr h="440771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R-574-5p+miR-3679-5p+miR-6165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789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5-1.003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3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.00%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.75%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4384687"/>
                  </a:ext>
                </a:extLst>
              </a:tr>
              <a:tr h="440771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R-574-5p+miR-3679-5p+miR-6760-5p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453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74-1.016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1.25%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.75%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0478815"/>
                  </a:ext>
                </a:extLst>
              </a:tr>
              <a:tr h="440771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R-6165+miR-3679-5p+miR-6760-5p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258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40-1.012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.00%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.75%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7874834"/>
                  </a:ext>
                </a:extLst>
              </a:tr>
              <a:tr h="440771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R-574-5p+miR-6165+miR-6760-5p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492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82-1.000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.50%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.50%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1826877"/>
                  </a:ext>
                </a:extLst>
              </a:tr>
              <a:tr h="440771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R-574-5p+miR-3679-5p+miR-6165+miR-6760-5p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453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74-1.016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1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.00%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.75%</a:t>
                      </a:r>
                      <a:endParaRPr lang="zh-CN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0720775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8040347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130</Words>
  <Application>Microsoft Macintosh PowerPoint</Application>
  <PresentationFormat>宽屏</PresentationFormat>
  <Paragraphs>7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unyu Wen</dc:creator>
  <cp:lastModifiedBy>Yunyu Wen</cp:lastModifiedBy>
  <cp:revision>3</cp:revision>
  <dcterms:created xsi:type="dcterms:W3CDTF">2020-02-06T09:14:03Z</dcterms:created>
  <dcterms:modified xsi:type="dcterms:W3CDTF">2020-02-06T09:37:47Z</dcterms:modified>
</cp:coreProperties>
</file>